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72" y="2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700B7E-68D3-4739-8116-2D860BE9FA01}" type="datetimeFigureOut">
              <a:rPr lang="en-US" smtClean="0"/>
              <a:pPr/>
              <a:t>1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436938-D82E-4DE2-BA71-47A96A25B81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600200" y="1905000"/>
            <a:ext cx="4572000" cy="6131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Table S2. Ingenuity Pathway Analysis top functional categories of the CNA-associated differentially expressed genes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752600" y="2667000"/>
          <a:ext cx="4114800" cy="21640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19200"/>
                <a:gridCol w="2895600"/>
              </a:tblGrid>
              <a:tr h="370840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000" b="1" i="0" kern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Molecular and Cellular Functions </a:t>
                      </a:r>
                      <a:endPara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000" b="1" i="0" kern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enes</a:t>
                      </a:r>
                      <a:endParaRPr kumimoji="0" lang="en-US" sz="10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anchor="ctr"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Cell Cycle</a:t>
                      </a:r>
                    </a:p>
                  </a:txBody>
                  <a:tcPr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2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000" i="0" kern="1200" dirty="0" smtClean="0">
                          <a:solidFill>
                            <a:schemeClr val="dk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CNG1, CD274, CTNNB1, HAUS1, PIAS1, PPP6C, RAD18, RAF1, SMAD4, TRIM33, UHRF2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horzOverflow="overflow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000" b="0" i="0" u="none" strike="noStrike" kern="1200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Gene Expression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horzOverflow="overflow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0" kern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ZI2, CRTC3, CTNNB1, FOXK1, FOXP1, HIRA, MAFK, MALT1, PIAS1, RAF1, SAP18, SMAD2, SMAD4, SNAPC3, TRIM33, YAP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horzOverflow="overflow">
                    <a:noFill/>
                  </a:tcPr>
                </a:tc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lang="en-US" sz="1000" i="0" kern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Cell Death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horzOverflow="overflow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0" fontAlgn="b" latinLnBrk="0" hangingPunct="0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i="0" kern="120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AZI2, CCNG1, CD274, CTNNB1, EOMES, FOXP1, HAUS1, LAPTM4B, MALT1, PIAS1, PPAP2A, PPP6C, PSIP1, RAD18, RAF1, SAP18, SMAD2, SMAD4, TXNL1, UHRF2, YAP1</a:t>
                      </a:r>
                      <a:endParaRPr kumimoji="0" lang="en-US" sz="1000" b="0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horzOverflow="overflow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2</TotalTime>
  <Words>119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Fred Hutchinson Cancer Research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Xu, Chang</dc:creator>
  <cp:lastModifiedBy>Xu, Chang</cp:lastModifiedBy>
  <cp:revision>38</cp:revision>
  <dcterms:created xsi:type="dcterms:W3CDTF">2011-06-08T23:30:32Z</dcterms:created>
  <dcterms:modified xsi:type="dcterms:W3CDTF">2012-12-01T00:54:45Z</dcterms:modified>
</cp:coreProperties>
</file>